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57" d="100"/>
          <a:sy n="57" d="100"/>
        </p:scale>
        <p:origin x="1866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mycn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fixedVal"/>
            <c:noEndCap val="0"/>
            <c:val val="0.2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:$A$4</c:f>
              <c:strCache>
                <c:ptCount val="3"/>
                <c:pt idx="0">
                  <c:v>NT</c:v>
                </c:pt>
                <c:pt idx="1">
                  <c:v>CTRLsi</c:v>
                </c:pt>
                <c:pt idx="2">
                  <c:v>CX3CR1si</c:v>
                </c:pt>
              </c:strCache>
            </c:strRef>
          </c:cat>
          <c:val>
            <c:numRef>
              <c:f>Sheet1!$B$2:$B$4</c:f>
              <c:numCache>
                <c:formatCode>General</c:formatCode>
                <c:ptCount val="3"/>
                <c:pt idx="0">
                  <c:v>1</c:v>
                </c:pt>
                <c:pt idx="1">
                  <c:v>1</c:v>
                </c:pt>
                <c:pt idx="2">
                  <c:v>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4148944"/>
        <c:axId val="144149504"/>
      </c:barChart>
      <c:catAx>
        <c:axId val="1441489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44149504"/>
        <c:crosses val="autoZero"/>
        <c:auto val="1"/>
        <c:lblAlgn val="ctr"/>
        <c:lblOffset val="100"/>
        <c:noMultiLvlLbl val="0"/>
      </c:catAx>
      <c:valAx>
        <c:axId val="14414950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 smtClean="0"/>
                  <a:t>MYCN</a:t>
                </a:r>
                <a:endParaRPr lang="en-US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44148944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61841-54D7-405F-A9DC-DF85951E17AB}" type="datetimeFigureOut">
              <a:rPr lang="en-US" smtClean="0"/>
              <a:t>2/1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005284-DF00-45F0-8765-9C123E6CAA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53343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61841-54D7-405F-A9DC-DF85951E17AB}" type="datetimeFigureOut">
              <a:rPr lang="en-US" smtClean="0"/>
              <a:t>2/1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005284-DF00-45F0-8765-9C123E6CAA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64540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61841-54D7-405F-A9DC-DF85951E17AB}" type="datetimeFigureOut">
              <a:rPr lang="en-US" smtClean="0"/>
              <a:t>2/1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005284-DF00-45F0-8765-9C123E6CAA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38671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61841-54D7-405F-A9DC-DF85951E17AB}" type="datetimeFigureOut">
              <a:rPr lang="en-US" smtClean="0"/>
              <a:t>2/1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005284-DF00-45F0-8765-9C123E6CAA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57921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61841-54D7-405F-A9DC-DF85951E17AB}" type="datetimeFigureOut">
              <a:rPr lang="en-US" smtClean="0"/>
              <a:t>2/1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005284-DF00-45F0-8765-9C123E6CAA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58669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61841-54D7-405F-A9DC-DF85951E17AB}" type="datetimeFigureOut">
              <a:rPr lang="en-US" smtClean="0"/>
              <a:t>2/1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005284-DF00-45F0-8765-9C123E6CAA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41601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61841-54D7-405F-A9DC-DF85951E17AB}" type="datetimeFigureOut">
              <a:rPr lang="en-US" smtClean="0"/>
              <a:t>2/17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005284-DF00-45F0-8765-9C123E6CAA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03764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61841-54D7-405F-A9DC-DF85951E17AB}" type="datetimeFigureOut">
              <a:rPr lang="en-US" smtClean="0"/>
              <a:t>2/17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005284-DF00-45F0-8765-9C123E6CAA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7638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61841-54D7-405F-A9DC-DF85951E17AB}" type="datetimeFigureOut">
              <a:rPr lang="en-US" smtClean="0"/>
              <a:t>2/17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005284-DF00-45F0-8765-9C123E6CAA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49280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61841-54D7-405F-A9DC-DF85951E17AB}" type="datetimeFigureOut">
              <a:rPr lang="en-US" smtClean="0"/>
              <a:t>2/1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005284-DF00-45F0-8765-9C123E6CAA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94894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61841-54D7-405F-A9DC-DF85951E17AB}" type="datetimeFigureOut">
              <a:rPr lang="en-US" smtClean="0"/>
              <a:t>2/1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005284-DF00-45F0-8765-9C123E6CAA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34100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461841-54D7-405F-A9DC-DF85951E17AB}" type="datetimeFigureOut">
              <a:rPr lang="en-US" smtClean="0"/>
              <a:t>2/1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005284-DF00-45F0-8765-9C123E6CAA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97801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2.png"/><Relationship Id="rId7" Type="http://schemas.openxmlformats.org/officeDocument/2006/relationships/image" Target="../media/image5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chart" Target="../charts/chart1.xml"/><Relationship Id="rId9" Type="http://schemas.openxmlformats.org/officeDocument/2006/relationships/image" Target="../media/image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4" name="Group 43"/>
          <p:cNvGrpSpPr/>
          <p:nvPr/>
        </p:nvGrpSpPr>
        <p:grpSpPr>
          <a:xfrm>
            <a:off x="48829" y="369338"/>
            <a:ext cx="2200967" cy="2089838"/>
            <a:chOff x="48829" y="549962"/>
            <a:chExt cx="2200967" cy="2089838"/>
          </a:xfrm>
        </p:grpSpPr>
        <p:pic>
          <p:nvPicPr>
            <p:cNvPr id="8" name="Picture 7"/>
            <p:cNvPicPr>
              <a:picLocks noChangeAspect="1"/>
            </p:cNvPicPr>
            <p:nvPr/>
          </p:nvPicPr>
          <p:blipFill rotWithShape="1">
            <a:blip r:embed="rId2"/>
            <a:srcRect l="20204" t="1850" r="16586" b="18870"/>
            <a:stretch/>
          </p:blipFill>
          <p:spPr>
            <a:xfrm>
              <a:off x="587020" y="632176"/>
              <a:ext cx="1463043" cy="1472527"/>
            </a:xfrm>
            <a:prstGeom prst="rect">
              <a:avLst/>
            </a:prstGeom>
          </p:spPr>
        </p:pic>
        <p:sp>
          <p:nvSpPr>
            <p:cNvPr id="9" name="TextBox 8"/>
            <p:cNvSpPr txBox="1"/>
            <p:nvPr/>
          </p:nvSpPr>
          <p:spPr>
            <a:xfrm>
              <a:off x="902456" y="632411"/>
              <a:ext cx="1213033" cy="4385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>
                <a:lnSpc>
                  <a:spcPts val="9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earson -0.221</a:t>
              </a:r>
            </a:p>
            <a:p>
              <a:pPr algn="r">
                <a:lnSpc>
                  <a:spcPts val="9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pearman -0.189</a:t>
              </a:r>
            </a:p>
            <a:p>
              <a:pPr algn="r">
                <a:lnSpc>
                  <a:spcPts val="900"/>
                </a:lnSpc>
              </a:pPr>
              <a:r>
                <a:rPr lang="en-US" sz="10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p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=0.043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437388" y="2066582"/>
              <a:ext cx="181240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3   -2  -1   0   1    2   3   4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391959" y="2239690"/>
              <a:ext cx="175956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X</a:t>
              </a:r>
              <a:r>
                <a:rPr lang="en-US" sz="1000" b="1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R1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, mRNA/miRNA </a:t>
              </a:r>
              <a:b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xpression z-scores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240334" y="549962"/>
              <a:ext cx="404552" cy="1631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>
                <a:lnSpc>
                  <a:spcPts val="12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  <a:p>
              <a:pPr algn="r">
                <a:lnSpc>
                  <a:spcPts val="12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  <a:p>
              <a:pPr algn="r">
                <a:lnSpc>
                  <a:spcPts val="12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  <a:p>
              <a:pPr algn="r">
                <a:lnSpc>
                  <a:spcPts val="12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  <a:p>
              <a:pPr algn="r">
                <a:lnSpc>
                  <a:spcPts val="12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  <a:p>
              <a:pPr algn="r">
                <a:lnSpc>
                  <a:spcPts val="12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  <a:p>
              <a:pPr algn="r">
                <a:lnSpc>
                  <a:spcPts val="12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1</a:t>
              </a:r>
            </a:p>
            <a:p>
              <a:pPr algn="r">
                <a:lnSpc>
                  <a:spcPts val="12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2</a:t>
              </a:r>
            </a:p>
            <a:p>
              <a:pPr algn="r">
                <a:lnSpc>
                  <a:spcPts val="12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3</a:t>
              </a:r>
            </a:p>
            <a:p>
              <a:pPr algn="r">
                <a:lnSpc>
                  <a:spcPts val="12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4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 rot="16200000">
              <a:off x="-522135" y="1180570"/>
              <a:ext cx="154203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YCN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, mRNA/miRNA</a:t>
              </a:r>
              <a:b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expression z-scores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0" name="TextBox 19"/>
          <p:cNvSpPr txBox="1"/>
          <p:nvPr/>
        </p:nvSpPr>
        <p:spPr>
          <a:xfrm>
            <a:off x="0" y="0"/>
            <a:ext cx="4013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Xie, et al; Supplementary Figure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2830455" y="357292"/>
            <a:ext cx="179557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NT     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TRLsi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CX</a:t>
            </a:r>
            <a:r>
              <a:rPr lang="en-US" sz="10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R1si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2268727" y="614757"/>
            <a:ext cx="9052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MYCN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2302594" y="914717"/>
            <a:ext cx="9052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CTB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2655720" y="157365"/>
            <a:ext cx="3840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3575" y="157365"/>
            <a:ext cx="3840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-159" y="2331701"/>
            <a:ext cx="3840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pSp>
        <p:nvGrpSpPr>
          <p:cNvPr id="43" name="Group 42"/>
          <p:cNvGrpSpPr/>
          <p:nvPr/>
        </p:nvGrpSpPr>
        <p:grpSpPr>
          <a:xfrm>
            <a:off x="4739129" y="381168"/>
            <a:ext cx="2262307" cy="2028393"/>
            <a:chOff x="4993130" y="561792"/>
            <a:chExt cx="2262307" cy="2028393"/>
          </a:xfrm>
        </p:grpSpPr>
        <p:pic>
          <p:nvPicPr>
            <p:cNvPr id="10" name="Picture 9"/>
            <p:cNvPicPr>
              <a:picLocks noChangeAspect="1"/>
            </p:cNvPicPr>
            <p:nvPr/>
          </p:nvPicPr>
          <p:blipFill rotWithShape="1">
            <a:blip r:embed="rId3"/>
            <a:srcRect l="19952" t="2228" r="17041" b="18745"/>
            <a:stretch/>
          </p:blipFill>
          <p:spPr>
            <a:xfrm>
              <a:off x="5510306" y="677714"/>
              <a:ext cx="1458348" cy="1467839"/>
            </a:xfrm>
            <a:prstGeom prst="rect">
              <a:avLst/>
            </a:prstGeom>
          </p:spPr>
        </p:pic>
        <p:sp>
          <p:nvSpPr>
            <p:cNvPr id="18" name="TextBox 17"/>
            <p:cNvSpPr txBox="1"/>
            <p:nvPr/>
          </p:nvSpPr>
          <p:spPr>
            <a:xfrm>
              <a:off x="5313084" y="2163480"/>
              <a:ext cx="194235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esistant Sensitive Too early 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492380" y="2343964"/>
              <a:ext cx="1524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LATINUM STATUS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5213670" y="590344"/>
              <a:ext cx="380304" cy="15802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>
                <a:lnSpc>
                  <a:spcPts val="13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  <a:p>
              <a:pPr algn="r">
                <a:lnSpc>
                  <a:spcPts val="13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  <a:p>
              <a:pPr algn="r">
                <a:lnSpc>
                  <a:spcPts val="13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  <a:p>
              <a:pPr algn="r">
                <a:lnSpc>
                  <a:spcPts val="13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  <a:p>
              <a:pPr algn="r">
                <a:lnSpc>
                  <a:spcPts val="13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  <a:p>
              <a:pPr algn="r">
                <a:lnSpc>
                  <a:spcPts val="13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  <a:p>
              <a:pPr algn="r">
                <a:lnSpc>
                  <a:spcPts val="13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1</a:t>
              </a:r>
            </a:p>
            <a:p>
              <a:pPr algn="r">
                <a:lnSpc>
                  <a:spcPts val="13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2</a:t>
              </a:r>
            </a:p>
            <a:p>
              <a:pPr algn="r">
                <a:lnSpc>
                  <a:spcPts val="13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3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 rot="16200000">
              <a:off x="4306251" y="1248671"/>
              <a:ext cx="177386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YCN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, </a:t>
              </a:r>
              <a:b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RNA expression z-scores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Left Bracket 40"/>
            <p:cNvSpPr/>
            <p:nvPr/>
          </p:nvSpPr>
          <p:spPr>
            <a:xfrm rot="5400000">
              <a:off x="5969443" y="586951"/>
              <a:ext cx="51730" cy="507787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5815107" y="642368"/>
              <a:ext cx="36835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7" name="TextBox 46"/>
          <p:cNvSpPr txBox="1"/>
          <p:nvPr/>
        </p:nvSpPr>
        <p:spPr>
          <a:xfrm>
            <a:off x="5178785" y="157365"/>
            <a:ext cx="3840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aphicFrame>
        <p:nvGraphicFramePr>
          <p:cNvPr id="63" name="Chart 62"/>
          <p:cNvGraphicFramePr/>
          <p:nvPr>
            <p:extLst>
              <p:ext uri="{D42A27DB-BD31-4B8C-83A1-F6EECF244321}">
                <p14:modId xmlns:p14="http://schemas.microsoft.com/office/powerpoint/2010/main" val="2249145497"/>
              </p:ext>
            </p:extLst>
          </p:nvPr>
        </p:nvGraphicFramePr>
        <p:xfrm>
          <a:off x="2178521" y="1077505"/>
          <a:ext cx="2220838" cy="151169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pSp>
        <p:nvGrpSpPr>
          <p:cNvPr id="79" name="Group 78"/>
          <p:cNvGrpSpPr/>
          <p:nvPr/>
        </p:nvGrpSpPr>
        <p:grpSpPr>
          <a:xfrm>
            <a:off x="4708468" y="2516662"/>
            <a:ext cx="2206223" cy="2187430"/>
            <a:chOff x="4708468" y="3408488"/>
            <a:chExt cx="2206223" cy="2187430"/>
          </a:xfrm>
        </p:grpSpPr>
        <p:pic>
          <p:nvPicPr>
            <p:cNvPr id="57" name="Picture 56"/>
            <p:cNvPicPr>
              <a:picLocks noChangeAspect="1"/>
            </p:cNvPicPr>
            <p:nvPr/>
          </p:nvPicPr>
          <p:blipFill rotWithShape="1">
            <a:blip r:embed="rId5"/>
            <a:srcRect l="20063" t="2233" r="16773" b="18769"/>
            <a:stretch/>
          </p:blipFill>
          <p:spPr>
            <a:xfrm>
              <a:off x="5236535" y="3583172"/>
              <a:ext cx="1461977" cy="1467293"/>
            </a:xfrm>
            <a:prstGeom prst="rect">
              <a:avLst/>
            </a:prstGeom>
          </p:spPr>
        </p:pic>
        <p:sp>
          <p:nvSpPr>
            <p:cNvPr id="70" name="TextBox 69"/>
            <p:cNvSpPr txBox="1"/>
            <p:nvPr/>
          </p:nvSpPr>
          <p:spPr>
            <a:xfrm>
              <a:off x="5539935" y="3585662"/>
              <a:ext cx="1213033" cy="4385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>
                <a:lnSpc>
                  <a:spcPts val="9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earson -0.149</a:t>
              </a:r>
            </a:p>
            <a:p>
              <a:pPr algn="r">
                <a:lnSpc>
                  <a:spcPts val="9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pearman -0.131</a:t>
              </a:r>
            </a:p>
            <a:p>
              <a:pPr algn="r">
                <a:lnSpc>
                  <a:spcPts val="900"/>
                </a:lnSpc>
              </a:pPr>
              <a:r>
                <a:rPr lang="en-US" sz="10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p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=0.057</a:t>
              </a:r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5141573" y="5030903"/>
              <a:ext cx="177311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4     -2       0       2      4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5077864" y="5195808"/>
              <a:ext cx="175956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YCN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, mRNA/miRNA </a:t>
              </a:r>
              <a:b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xpression z-scores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4877609" y="3651212"/>
              <a:ext cx="442697" cy="13237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>
                <a:lnSpc>
                  <a:spcPts val="25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  <a:p>
              <a:pPr algn="r">
                <a:lnSpc>
                  <a:spcPts val="25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  <a:p>
              <a:pPr algn="r">
                <a:lnSpc>
                  <a:spcPts val="25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4</a:t>
              </a:r>
            </a:p>
            <a:p>
              <a:pPr algn="r">
                <a:lnSpc>
                  <a:spcPts val="25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8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TextBox 73"/>
            <p:cNvSpPr txBox="1"/>
            <p:nvPr/>
          </p:nvSpPr>
          <p:spPr>
            <a:xfrm rot="16200000">
              <a:off x="4028740" y="4088216"/>
              <a:ext cx="175956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BN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, mRNA/miRNA </a:t>
              </a:r>
              <a:b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xpression z-scores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0" name="Group 79"/>
          <p:cNvGrpSpPr/>
          <p:nvPr/>
        </p:nvGrpSpPr>
        <p:grpSpPr>
          <a:xfrm>
            <a:off x="2267673" y="2513253"/>
            <a:ext cx="2185585" cy="2186466"/>
            <a:chOff x="2267673" y="3405079"/>
            <a:chExt cx="2185585" cy="2186466"/>
          </a:xfrm>
        </p:grpSpPr>
        <p:pic>
          <p:nvPicPr>
            <p:cNvPr id="56" name="Picture 55"/>
            <p:cNvPicPr>
              <a:picLocks noChangeAspect="1"/>
            </p:cNvPicPr>
            <p:nvPr/>
          </p:nvPicPr>
          <p:blipFill rotWithShape="1">
            <a:blip r:embed="rId6"/>
            <a:srcRect l="19961" t="1662" r="17105" b="19054"/>
            <a:stretch/>
          </p:blipFill>
          <p:spPr>
            <a:xfrm>
              <a:off x="2775098" y="3572540"/>
              <a:ext cx="1456660" cy="1472609"/>
            </a:xfrm>
            <a:prstGeom prst="rect">
              <a:avLst/>
            </a:prstGeom>
          </p:spPr>
        </p:pic>
        <p:sp>
          <p:nvSpPr>
            <p:cNvPr id="67" name="TextBox 66"/>
            <p:cNvSpPr txBox="1"/>
            <p:nvPr/>
          </p:nvSpPr>
          <p:spPr>
            <a:xfrm>
              <a:off x="3075635" y="3579255"/>
              <a:ext cx="1213033" cy="4385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>
                <a:lnSpc>
                  <a:spcPts val="9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earson -0.141</a:t>
              </a:r>
            </a:p>
            <a:p>
              <a:pPr algn="r">
                <a:lnSpc>
                  <a:spcPts val="9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pearman -0.137</a:t>
              </a:r>
            </a:p>
            <a:p>
              <a:pPr algn="r">
                <a:lnSpc>
                  <a:spcPts val="900"/>
                </a:lnSpc>
              </a:pPr>
              <a:r>
                <a:rPr lang="en-US" sz="10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p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=0.013</a:t>
              </a:r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2680140" y="5031301"/>
              <a:ext cx="177311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4     -2       0       2      4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2616886" y="5191435"/>
              <a:ext cx="175956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YCN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, mRNA/miRNA </a:t>
              </a:r>
              <a:b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xpression z-scores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2518963" y="3593810"/>
              <a:ext cx="354022" cy="13397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>
                <a:lnSpc>
                  <a:spcPts val="20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  <a:p>
              <a:pPr algn="r">
                <a:lnSpc>
                  <a:spcPts val="20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  <a:p>
              <a:pPr algn="r">
                <a:lnSpc>
                  <a:spcPts val="20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  <a:p>
              <a:pPr algn="r">
                <a:lnSpc>
                  <a:spcPts val="20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2</a:t>
              </a:r>
            </a:p>
            <a:p>
              <a:pPr algn="r">
                <a:lnSpc>
                  <a:spcPts val="20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4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TextBox 75"/>
            <p:cNvSpPr txBox="1"/>
            <p:nvPr/>
          </p:nvSpPr>
          <p:spPr>
            <a:xfrm rot="16200000">
              <a:off x="1587945" y="4084807"/>
              <a:ext cx="175956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AD50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, mRNA/miRNA </a:t>
              </a:r>
              <a:b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xpression z-scores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1" name="Group 80"/>
          <p:cNvGrpSpPr/>
          <p:nvPr/>
        </p:nvGrpSpPr>
        <p:grpSpPr>
          <a:xfrm>
            <a:off x="11705" y="2484877"/>
            <a:ext cx="2184930" cy="2188675"/>
            <a:chOff x="11705" y="3376703"/>
            <a:chExt cx="2184930" cy="2188675"/>
          </a:xfrm>
        </p:grpSpPr>
        <p:pic>
          <p:nvPicPr>
            <p:cNvPr id="55" name="Picture 54"/>
            <p:cNvPicPr>
              <a:picLocks noChangeAspect="1"/>
            </p:cNvPicPr>
            <p:nvPr/>
          </p:nvPicPr>
          <p:blipFill rotWithShape="1">
            <a:blip r:embed="rId7"/>
            <a:srcRect l="19583" t="2581" r="17023" b="19280"/>
            <a:stretch/>
          </p:blipFill>
          <p:spPr>
            <a:xfrm>
              <a:off x="515679" y="3561907"/>
              <a:ext cx="1467294" cy="1451344"/>
            </a:xfrm>
            <a:prstGeom prst="rect">
              <a:avLst/>
            </a:prstGeom>
          </p:spPr>
        </p:pic>
        <p:sp>
          <p:nvSpPr>
            <p:cNvPr id="64" name="TextBox 63"/>
            <p:cNvSpPr txBox="1"/>
            <p:nvPr/>
          </p:nvSpPr>
          <p:spPr>
            <a:xfrm>
              <a:off x="826455" y="3559507"/>
              <a:ext cx="1213033" cy="4385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>
                <a:lnSpc>
                  <a:spcPts val="9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earson 0.057</a:t>
              </a:r>
            </a:p>
            <a:p>
              <a:pPr algn="r">
                <a:lnSpc>
                  <a:spcPts val="9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pearman 0.067</a:t>
              </a:r>
            </a:p>
            <a:p>
              <a:pPr algn="r">
                <a:lnSpc>
                  <a:spcPts val="900"/>
                </a:lnSpc>
              </a:pPr>
              <a:r>
                <a:rPr lang="en-US" sz="10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=0.129</a:t>
              </a: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423517" y="5002623"/>
              <a:ext cx="177311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4     -2       0       2      4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384752" y="5165268"/>
              <a:ext cx="175956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YCN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, mRNA/miRNA </a:t>
              </a:r>
              <a:b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xpression z-scores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101471" y="3434319"/>
              <a:ext cx="509903" cy="15225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>
                <a:lnSpc>
                  <a:spcPts val="19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  <a:p>
              <a:pPr algn="r">
                <a:lnSpc>
                  <a:spcPts val="19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  <a:p>
              <a:pPr algn="r">
                <a:lnSpc>
                  <a:spcPts val="19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  <a:p>
              <a:pPr algn="r">
                <a:lnSpc>
                  <a:spcPts val="19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  <a:p>
              <a:pPr algn="r">
                <a:lnSpc>
                  <a:spcPts val="19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2</a:t>
              </a:r>
            </a:p>
            <a:p>
              <a:pPr algn="r">
                <a:lnSpc>
                  <a:spcPts val="19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4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TextBox 77"/>
            <p:cNvSpPr txBox="1"/>
            <p:nvPr/>
          </p:nvSpPr>
          <p:spPr>
            <a:xfrm rot="16200000">
              <a:off x="-668023" y="4056431"/>
              <a:ext cx="175956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RE11A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, mRNA/miRNA </a:t>
              </a:r>
              <a:b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xpression z-scores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2" name="Left Bracket 81"/>
          <p:cNvSpPr/>
          <p:nvPr/>
        </p:nvSpPr>
        <p:spPr>
          <a:xfrm rot="5400000">
            <a:off x="3716733" y="1054211"/>
            <a:ext cx="87290" cy="507787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3" name="TextBox 82"/>
          <p:cNvSpPr txBox="1"/>
          <p:nvPr/>
        </p:nvSpPr>
        <p:spPr>
          <a:xfrm>
            <a:off x="3580177" y="1214498"/>
            <a:ext cx="3683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8"/>
          <a:srcRect l="19563" t="32276" r="2666" b="61903"/>
          <a:stretch/>
        </p:blipFill>
        <p:spPr>
          <a:xfrm>
            <a:off x="2787845" y="631827"/>
            <a:ext cx="1466669" cy="22915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4" name="Picture 3" descr="C:\Users\jsacks3\Desktop\OVCAR4_siCX3CR1_MYCN_betaactin_2min_exp.jpg"/>
          <p:cNvPicPr>
            <a:picLocks noChangeAspect="1" noChangeArrowheads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795" t="46557" r="31408" b="45042"/>
          <a:stretch/>
        </p:blipFill>
        <p:spPr bwMode="auto">
          <a:xfrm>
            <a:off x="2787845" y="952674"/>
            <a:ext cx="1466670" cy="174093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9798275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21</TotalTime>
  <Words>160</Words>
  <Application>Microsoft Office PowerPoint</Application>
  <PresentationFormat>On-screen Show (4:3)</PresentationFormat>
  <Paragraphs>7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rbolina, Maria</dc:creator>
  <cp:lastModifiedBy>Barbolina, Maria</cp:lastModifiedBy>
  <cp:revision>32</cp:revision>
  <cp:lastPrinted>2017-02-21T16:59:17Z</cp:lastPrinted>
  <dcterms:created xsi:type="dcterms:W3CDTF">2017-01-23T16:38:26Z</dcterms:created>
  <dcterms:modified xsi:type="dcterms:W3CDTF">2018-02-18T01:17:00Z</dcterms:modified>
</cp:coreProperties>
</file>